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BA5AE-A61A-418F-9CB1-42F00E7B13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73211-1004-4D0D-B3C9-F0861B38E2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32C6C-B943-463A-9138-DF12F4A53C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E7D54-8756-4513-864C-7CE1E5E21F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4C0FE-0019-4B3E-A1EE-C307E69B64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95746-AE83-43A6-BBB5-D8CBBDDCF9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53728-DB01-41EE-93BB-880BF9E6E6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3A4E0-9FFD-47F3-A023-CCB23B1062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0A3B2-46EB-4C2E-9782-4C3EDA9B83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D0917-871B-4035-9165-D7A841F36A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707EF-C1D3-4C73-9450-CD48F099FF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373EF-F30F-4AEC-9A6C-9C11229808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FD38CC-3C5B-4A37-8286-C784BAD403B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re and distinguishing functions of human body site microbiom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1371600" y="1697040"/>
            <a:ext cx="6400800" cy="34941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J Lloyd-Pric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6 (2017) doi:10.1038/nature238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6T09:00:41Z</dcterms:created>
  <dc:creator>ravikumar.n</dc:creator>
  <dc:description/>
  <dc:language>en-US</dc:language>
  <cp:lastModifiedBy>ravikumar.n</cp:lastModifiedBy>
  <dcterms:modified xsi:type="dcterms:W3CDTF">2017-09-16T09:00:46Z</dcterms:modified>
  <cp:revision>1</cp:revision>
  <dc:subject/>
  <dc:title>Core and distinguishing functions of human body site microbiomes</dc:title>
</cp:coreProperties>
</file>